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75" r:id="rId2"/>
    <p:sldId id="28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DA7424-F72B-1EB5-697F-CA9333E57F0A}" name="PhilR" initials="PJR" userId="PhilR" providerId="None"/>
  <p188:author id="{3B063878-6895-4B8D-823B-C7D9104357F1}" name="Roger Reddel" initials="RR" userId="S::rreddel@cmri.org.au::750bfe6e-02cc-4cce-a1ed-bde13e6cbbb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13" autoAdjust="0"/>
    <p:restoredTop sz="95748" autoAdjust="0"/>
  </p:normalViewPr>
  <p:slideViewPr>
    <p:cSldViewPr snapToGrid="0">
      <p:cViewPr varScale="1">
        <p:scale>
          <a:sx n="69" d="100"/>
          <a:sy n="69" d="100"/>
        </p:scale>
        <p:origin x="23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BFE566-B291-6C40-A8EB-8EA7FEA7A444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0A3A11-C076-CF4F-B186-F8DBC4F2A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979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9312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0091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6602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3282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4586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539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112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6183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182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81319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9719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589C1-DA9D-4EBB-B7E3-2ADCFB361F1E}" type="datetimeFigureOut">
              <a:rPr lang="en-AU" smtClean="0"/>
              <a:t>24/02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73648-EEB1-4118-BF6B-90F860888EB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5162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2744DD4-DB9B-4B2B-AFA2-F91E31D8B5EC}"/>
              </a:ext>
            </a:extLst>
          </p:cNvPr>
          <p:cNvSpPr txBox="1"/>
          <p:nvPr/>
        </p:nvSpPr>
        <p:spPr>
          <a:xfrm>
            <a:off x="235969" y="598942"/>
            <a:ext cx="529955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5161221-CC6F-45C5-BCAF-CCFC7497EB4C}"/>
              </a:ext>
            </a:extLst>
          </p:cNvPr>
          <p:cNvSpPr txBox="1"/>
          <p:nvPr/>
        </p:nvSpPr>
        <p:spPr>
          <a:xfrm>
            <a:off x="205478" y="4850097"/>
            <a:ext cx="529955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BB4DAD-5840-4FA9-889E-54EFA3183BD3}"/>
              </a:ext>
            </a:extLst>
          </p:cNvPr>
          <p:cNvSpPr txBox="1"/>
          <p:nvPr/>
        </p:nvSpPr>
        <p:spPr>
          <a:xfrm>
            <a:off x="618438" y="672645"/>
            <a:ext cx="5828927" cy="618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athways for 318 peptides (from 181 unique proteins) up-regulated in Recurrence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FBE9733-62C8-47A4-B1D7-291F75AFFCBD}"/>
              </a:ext>
            </a:extLst>
          </p:cNvPr>
          <p:cNvSpPr txBox="1"/>
          <p:nvPr/>
        </p:nvSpPr>
        <p:spPr>
          <a:xfrm>
            <a:off x="618439" y="4923194"/>
            <a:ext cx="6034084" cy="618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athways for 87 peptides (from 52 unique proteins) down-regulated in Recurrence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1CFF26F-C27B-3FDC-087E-FF70A7177E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478" y="1281521"/>
            <a:ext cx="6447044" cy="353622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2B12B55-75C9-1464-F14C-2413AEDC480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478" y="5526645"/>
            <a:ext cx="6447044" cy="352985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0B742AF-D606-4D7D-5FDE-F5282C7BF8AB}"/>
              </a:ext>
            </a:extLst>
          </p:cNvPr>
          <p:cNvSpPr txBox="1"/>
          <p:nvPr/>
        </p:nvSpPr>
        <p:spPr>
          <a:xfrm>
            <a:off x="262702" y="26393"/>
            <a:ext cx="3996814" cy="3262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n-AU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83381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802D3C5-01DE-452D-B3F1-3F63F7383314}"/>
              </a:ext>
            </a:extLst>
          </p:cNvPr>
          <p:cNvSpPr txBox="1"/>
          <p:nvPr/>
        </p:nvSpPr>
        <p:spPr>
          <a:xfrm>
            <a:off x="2802195" y="9493102"/>
            <a:ext cx="3996814" cy="428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ct val="95000"/>
              </a:lnSpc>
            </a:pPr>
            <a:r>
              <a:rPr lang="en-US" sz="2300" dirty="0">
                <a:latin typeface="Arial" panose="020B0604020202020204" pitchFamily="34" charset="0"/>
                <a:cs typeface="Arial" panose="020B0604020202020204" pitchFamily="34" charset="0"/>
              </a:rPr>
              <a:t> Supplementary Figure S4</a:t>
            </a:r>
            <a:endParaRPr lang="en-AU" sz="2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5C9E29A-FE5A-4B4F-37F6-ECC34ED76F8E}"/>
              </a:ext>
            </a:extLst>
          </p:cNvPr>
          <p:cNvSpPr txBox="1"/>
          <p:nvPr/>
        </p:nvSpPr>
        <p:spPr>
          <a:xfrm>
            <a:off x="325665" y="461488"/>
            <a:ext cx="6206669" cy="27213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Supplementary Figure S4: Top 15 cellular functions and pathways for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DAPep</a:t>
            </a: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AU" sz="1200" b="1" dirty="0" err="1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tumor</a:t>
            </a:r>
            <a:r>
              <a:rPr lang="en-AU" sz="1200" b="1" dirty="0">
                <a:effectLst/>
                <a:latin typeface="Calibri" panose="020F0502020204030204" pitchFamily="34" charset="0"/>
                <a:ea typeface="DengXian Light" panose="02010600030101010101" pitchFamily="2" charset="-122"/>
                <a:cs typeface="Times New Roman" panose="02020603050405020304" pitchFamily="18" charset="0"/>
              </a:rPr>
              <a:t> samples from recurrence vs non-recurrence</a:t>
            </a:r>
          </a:p>
          <a:p>
            <a:pPr>
              <a:lnSpc>
                <a:spcPct val="150000"/>
              </a:lnSpc>
            </a:pP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mpacted pathways were analyzed separately for the </a:t>
            </a:r>
            <a:r>
              <a:rPr lang="en-AU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up-regulated or </a:t>
            </a:r>
            <a:r>
              <a:rPr lang="en-AU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down-regulated proteins associated with the DAPeps according to the number of proteins in that function (# genes) and </a:t>
            </a:r>
            <a:r>
              <a:rPr lang="en-AU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lored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ccording to the adjusted </a:t>
            </a:r>
            <a:r>
              <a:rPr lang="en-AU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.  Pathways were identified for 318 peptides (181 unique proteins) up-regulated in 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currence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r 87 peptides (52 proteins) down-regulated in 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currence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Pathways up-regulated in the 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currence 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roup 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cluded 227 GO Biological Processes, 8 KEGG Pathways and 12 </a:t>
            </a:r>
            <a:r>
              <a:rPr lang="en-AU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actome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athways</a:t>
            </a: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and those down-regulated included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83 GO Biological Processes, 5 KEGG Pathways and 23 </a:t>
            </a:r>
            <a:r>
              <a:rPr lang="en-AU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actome</a:t>
            </a:r>
            <a:r>
              <a:rPr lang="en-AU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athways.</a:t>
            </a:r>
            <a:endParaRPr lang="en-AU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AU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1884637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95</TotalTime>
  <Words>157</Words>
  <Application>Microsoft Office PowerPoint</Application>
  <PresentationFormat>A4 Paper (210x297 mm)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R</dc:creator>
  <cp:lastModifiedBy>PhilR</cp:lastModifiedBy>
  <cp:revision>325</cp:revision>
  <dcterms:created xsi:type="dcterms:W3CDTF">2022-08-07T22:18:57Z</dcterms:created>
  <dcterms:modified xsi:type="dcterms:W3CDTF">2025-02-23T23:02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XPowerLiteLastOptimized">
    <vt:lpwstr>4123633</vt:lpwstr>
  </property>
  <property fmtid="{D5CDD505-2E9C-101B-9397-08002B2CF9AE}" pid="3" name="NXPowerLiteSettings">
    <vt:lpwstr>E9000A40064001</vt:lpwstr>
  </property>
  <property fmtid="{D5CDD505-2E9C-101B-9397-08002B2CF9AE}" pid="4" name="NXPowerLiteVersion">
    <vt:lpwstr>D9.1.2</vt:lpwstr>
  </property>
</Properties>
</file>